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86D3D-F514-4239-9D7F-CE91EBD90D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EDA53-EA3D-425E-BD8B-24C29429E8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34DA5-7F0F-4DC7-8F1B-4B8FBA3D6D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08BF5-B4AA-43FE-B202-421FF40813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79BB7-30B4-4686-AB18-2B6194624A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3D3B5E-F447-4F51-9CBF-1A1B7A1820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867C9-1896-42B4-99FF-FE74D8DFEC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BF3B2-24A5-4FC9-AEF1-21699CD7DF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A7348-EC20-4F12-83E6-315907CEF2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349155-344F-438E-AA9C-9A0C7ACFAD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CB848-F9DC-43EF-8D81-2681C0B94F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0511D-09EC-446A-93CB-2BD66C8C6C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37A978-D567-4F28-9266-882C1F8105BA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49"/>
          <p:cNvSpPr/>
          <p:nvPr/>
        </p:nvSpPr>
        <p:spPr>
          <a:xfrm>
            <a:off x="3121200" y="1984320"/>
            <a:ext cx="12600" cy="150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97"/>
          <p:cNvSpPr/>
          <p:nvPr/>
        </p:nvSpPr>
        <p:spPr>
          <a:xfrm>
            <a:off x="2975040" y="2013120"/>
            <a:ext cx="34920" cy="145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81"/>
          <p:cNvSpPr/>
          <p:nvPr/>
        </p:nvSpPr>
        <p:spPr>
          <a:xfrm flipV="1">
            <a:off x="2798640" y="4005000"/>
            <a:ext cx="5256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45"/>
          <p:cNvSpPr/>
          <p:nvPr/>
        </p:nvSpPr>
        <p:spPr>
          <a:xfrm flipV="1">
            <a:off x="2959200" y="4044960"/>
            <a:ext cx="33120" cy="147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57"/>
          <p:cNvSpPr/>
          <p:nvPr/>
        </p:nvSpPr>
        <p:spPr>
          <a:xfrm flipH="1">
            <a:off x="3936960" y="2373480"/>
            <a:ext cx="115920" cy="98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53"/>
          <p:cNvSpPr/>
          <p:nvPr/>
        </p:nvSpPr>
        <p:spPr>
          <a:xfrm flipH="1">
            <a:off x="3800520" y="2241720"/>
            <a:ext cx="93600" cy="117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26"/>
          <p:cNvSpPr/>
          <p:nvPr/>
        </p:nvSpPr>
        <p:spPr>
          <a:xfrm flipH="1">
            <a:off x="3227040" y="1836720"/>
            <a:ext cx="3348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Freeform 6"/>
          <p:cNvSpPr/>
          <p:nvPr/>
        </p:nvSpPr>
        <p:spPr>
          <a:xfrm>
            <a:off x="2230560" y="2131920"/>
            <a:ext cx="1955520" cy="1957320"/>
          </a:xfrm>
          <a:custGeom>
            <a:avLst/>
            <a:gdLst>
              <a:gd name="textAreaLeft" fmla="*/ 0 w 1955520"/>
              <a:gd name="textAreaRight" fmla="*/ 1955880 w 1955520"/>
              <a:gd name="textAreaTop" fmla="*/ 0 h 1957320"/>
              <a:gd name="textAreaBottom" fmla="*/ 1957320 h 1957320"/>
            </a:gdLst>
            <a:ahLst/>
            <a:rect l="textAreaLeft" t="textAreaTop" r="textAreaRight" b="textAreaBottom"/>
            <a:pathLst>
              <a:path w="1232" h="1233">
                <a:moveTo>
                  <a:pt x="622" y="0"/>
                </a:moveTo>
                <a:lnTo>
                  <a:pt x="567" y="2"/>
                </a:lnTo>
                <a:lnTo>
                  <a:pt x="513" y="10"/>
                </a:lnTo>
                <a:lnTo>
                  <a:pt x="458" y="20"/>
                </a:lnTo>
                <a:lnTo>
                  <a:pt x="406" y="37"/>
                </a:lnTo>
                <a:lnTo>
                  <a:pt x="354" y="58"/>
                </a:lnTo>
                <a:lnTo>
                  <a:pt x="306" y="84"/>
                </a:lnTo>
                <a:lnTo>
                  <a:pt x="260" y="115"/>
                </a:lnTo>
                <a:lnTo>
                  <a:pt x="216" y="148"/>
                </a:lnTo>
                <a:lnTo>
                  <a:pt x="176" y="186"/>
                </a:lnTo>
                <a:lnTo>
                  <a:pt x="140" y="227"/>
                </a:lnTo>
                <a:lnTo>
                  <a:pt x="106" y="271"/>
                </a:lnTo>
                <a:lnTo>
                  <a:pt x="77" y="317"/>
                </a:lnTo>
                <a:lnTo>
                  <a:pt x="53" y="367"/>
                </a:lnTo>
                <a:lnTo>
                  <a:pt x="33" y="419"/>
                </a:lnTo>
                <a:lnTo>
                  <a:pt x="18" y="471"/>
                </a:lnTo>
                <a:lnTo>
                  <a:pt x="7" y="525"/>
                </a:lnTo>
                <a:lnTo>
                  <a:pt x="1" y="580"/>
                </a:lnTo>
                <a:lnTo>
                  <a:pt x="0" y="635"/>
                </a:lnTo>
                <a:lnTo>
                  <a:pt x="4" y="690"/>
                </a:lnTo>
                <a:lnTo>
                  <a:pt x="13" y="744"/>
                </a:lnTo>
                <a:lnTo>
                  <a:pt x="27" y="798"/>
                </a:lnTo>
                <a:lnTo>
                  <a:pt x="45" y="849"/>
                </a:lnTo>
                <a:lnTo>
                  <a:pt x="70" y="900"/>
                </a:lnTo>
                <a:lnTo>
                  <a:pt x="97" y="947"/>
                </a:lnTo>
                <a:lnTo>
                  <a:pt x="127" y="993"/>
                </a:lnTo>
                <a:lnTo>
                  <a:pt x="164" y="1034"/>
                </a:lnTo>
                <a:lnTo>
                  <a:pt x="202" y="1073"/>
                </a:lnTo>
                <a:lnTo>
                  <a:pt x="245" y="1108"/>
                </a:lnTo>
                <a:lnTo>
                  <a:pt x="290" y="1139"/>
                </a:lnTo>
                <a:lnTo>
                  <a:pt x="339" y="1166"/>
                </a:lnTo>
                <a:lnTo>
                  <a:pt x="389" y="1189"/>
                </a:lnTo>
                <a:lnTo>
                  <a:pt x="441" y="1207"/>
                </a:lnTo>
                <a:lnTo>
                  <a:pt x="494" y="1221"/>
                </a:lnTo>
                <a:lnTo>
                  <a:pt x="549" y="1228"/>
                </a:lnTo>
                <a:lnTo>
                  <a:pt x="604" y="1233"/>
                </a:lnTo>
                <a:lnTo>
                  <a:pt x="659" y="1231"/>
                </a:lnTo>
                <a:lnTo>
                  <a:pt x="713" y="1224"/>
                </a:lnTo>
                <a:lnTo>
                  <a:pt x="768" y="1213"/>
                </a:lnTo>
                <a:lnTo>
                  <a:pt x="820" y="1198"/>
                </a:lnTo>
                <a:lnTo>
                  <a:pt x="872" y="1177"/>
                </a:lnTo>
                <a:lnTo>
                  <a:pt x="920" y="1152"/>
                </a:lnTo>
                <a:lnTo>
                  <a:pt x="968" y="1122"/>
                </a:lnTo>
                <a:lnTo>
                  <a:pt x="1012" y="1090"/>
                </a:lnTo>
                <a:lnTo>
                  <a:pt x="1051" y="1052"/>
                </a:lnTo>
                <a:lnTo>
                  <a:pt x="1089" y="1011"/>
                </a:lnTo>
                <a:lnTo>
                  <a:pt x="1123" y="968"/>
                </a:lnTo>
                <a:lnTo>
                  <a:pt x="1152" y="921"/>
                </a:lnTo>
                <a:lnTo>
                  <a:pt x="1176" y="872"/>
                </a:lnTo>
                <a:lnTo>
                  <a:pt x="1197" y="821"/>
                </a:lnTo>
                <a:lnTo>
                  <a:pt x="1213" y="769"/>
                </a:lnTo>
                <a:lnTo>
                  <a:pt x="1225" y="714"/>
                </a:lnTo>
                <a:lnTo>
                  <a:pt x="1231" y="659"/>
                </a:lnTo>
                <a:lnTo>
                  <a:pt x="1232" y="604"/>
                </a:lnTo>
                <a:lnTo>
                  <a:pt x="1229" y="550"/>
                </a:lnTo>
                <a:lnTo>
                  <a:pt x="1220" y="495"/>
                </a:lnTo>
                <a:lnTo>
                  <a:pt x="1207" y="442"/>
                </a:lnTo>
                <a:lnTo>
                  <a:pt x="1190" y="390"/>
                </a:lnTo>
                <a:lnTo>
                  <a:pt x="1167" y="340"/>
                </a:lnTo>
                <a:lnTo>
                  <a:pt x="1140" y="291"/>
                </a:lnTo>
                <a:lnTo>
                  <a:pt x="1109" y="245"/>
                </a:lnTo>
                <a:lnTo>
                  <a:pt x="1074" y="203"/>
                </a:lnTo>
                <a:lnTo>
                  <a:pt x="1035" y="165"/>
                </a:lnTo>
                <a:lnTo>
                  <a:pt x="992" y="128"/>
                </a:lnTo>
                <a:lnTo>
                  <a:pt x="948" y="96"/>
                </a:lnTo>
                <a:lnTo>
                  <a:pt x="899" y="69"/>
                </a:lnTo>
                <a:lnTo>
                  <a:pt x="850" y="46"/>
                </a:lnTo>
                <a:lnTo>
                  <a:pt x="799" y="28"/>
                </a:lnTo>
                <a:lnTo>
                  <a:pt x="744" y="14"/>
                </a:lnTo>
                <a:lnTo>
                  <a:pt x="691" y="5"/>
                </a:lnTo>
                <a:lnTo>
                  <a:pt x="636" y="0"/>
                </a:lnTo>
                <a:lnTo>
                  <a:pt x="622" y="0"/>
                </a:lnTo>
                <a:lnTo>
                  <a:pt x="622" y="14"/>
                </a:lnTo>
                <a:lnTo>
                  <a:pt x="677" y="16"/>
                </a:lnTo>
                <a:lnTo>
                  <a:pt x="730" y="25"/>
                </a:lnTo>
                <a:lnTo>
                  <a:pt x="782" y="37"/>
                </a:lnTo>
                <a:lnTo>
                  <a:pt x="834" y="54"/>
                </a:lnTo>
                <a:lnTo>
                  <a:pt x="882" y="75"/>
                </a:lnTo>
                <a:lnTo>
                  <a:pt x="930" y="101"/>
                </a:lnTo>
                <a:lnTo>
                  <a:pt x="975" y="131"/>
                </a:lnTo>
                <a:lnTo>
                  <a:pt x="1016" y="165"/>
                </a:lnTo>
                <a:lnTo>
                  <a:pt x="1056" y="203"/>
                </a:lnTo>
                <a:lnTo>
                  <a:pt x="1091" y="244"/>
                </a:lnTo>
                <a:lnTo>
                  <a:pt x="1121" y="288"/>
                </a:lnTo>
                <a:lnTo>
                  <a:pt x="1149" y="334"/>
                </a:lnTo>
                <a:lnTo>
                  <a:pt x="1173" y="382"/>
                </a:lnTo>
                <a:lnTo>
                  <a:pt x="1191" y="434"/>
                </a:lnTo>
                <a:lnTo>
                  <a:pt x="1205" y="486"/>
                </a:lnTo>
                <a:lnTo>
                  <a:pt x="1214" y="539"/>
                </a:lnTo>
                <a:lnTo>
                  <a:pt x="1219" y="592"/>
                </a:lnTo>
                <a:lnTo>
                  <a:pt x="1219" y="647"/>
                </a:lnTo>
                <a:lnTo>
                  <a:pt x="1214" y="700"/>
                </a:lnTo>
                <a:lnTo>
                  <a:pt x="1203" y="754"/>
                </a:lnTo>
                <a:lnTo>
                  <a:pt x="1190" y="805"/>
                </a:lnTo>
                <a:lnTo>
                  <a:pt x="1170" y="856"/>
                </a:lnTo>
                <a:lnTo>
                  <a:pt x="1146" y="904"/>
                </a:lnTo>
                <a:lnTo>
                  <a:pt x="1118" y="950"/>
                </a:lnTo>
                <a:lnTo>
                  <a:pt x="1086" y="994"/>
                </a:lnTo>
                <a:lnTo>
                  <a:pt x="1051" y="1034"/>
                </a:lnTo>
                <a:lnTo>
                  <a:pt x="1012" y="1072"/>
                </a:lnTo>
                <a:lnTo>
                  <a:pt x="969" y="1105"/>
                </a:lnTo>
                <a:lnTo>
                  <a:pt x="925" y="1134"/>
                </a:lnTo>
                <a:lnTo>
                  <a:pt x="878" y="1160"/>
                </a:lnTo>
                <a:lnTo>
                  <a:pt x="828" y="1181"/>
                </a:lnTo>
                <a:lnTo>
                  <a:pt x="776" y="1198"/>
                </a:lnTo>
                <a:lnTo>
                  <a:pt x="724" y="1210"/>
                </a:lnTo>
                <a:lnTo>
                  <a:pt x="671" y="1216"/>
                </a:lnTo>
                <a:lnTo>
                  <a:pt x="616" y="1219"/>
                </a:lnTo>
                <a:lnTo>
                  <a:pt x="563" y="1216"/>
                </a:lnTo>
                <a:lnTo>
                  <a:pt x="509" y="1210"/>
                </a:lnTo>
                <a:lnTo>
                  <a:pt x="456" y="1198"/>
                </a:lnTo>
                <a:lnTo>
                  <a:pt x="404" y="1181"/>
                </a:lnTo>
                <a:lnTo>
                  <a:pt x="356" y="1160"/>
                </a:lnTo>
                <a:lnTo>
                  <a:pt x="309" y="1134"/>
                </a:lnTo>
                <a:lnTo>
                  <a:pt x="263" y="1105"/>
                </a:lnTo>
                <a:lnTo>
                  <a:pt x="220" y="1072"/>
                </a:lnTo>
                <a:lnTo>
                  <a:pt x="182" y="1034"/>
                </a:lnTo>
                <a:lnTo>
                  <a:pt x="146" y="994"/>
                </a:lnTo>
                <a:lnTo>
                  <a:pt x="114" y="950"/>
                </a:lnTo>
                <a:lnTo>
                  <a:pt x="86" y="904"/>
                </a:lnTo>
                <a:lnTo>
                  <a:pt x="62" y="856"/>
                </a:lnTo>
                <a:lnTo>
                  <a:pt x="44" y="805"/>
                </a:lnTo>
                <a:lnTo>
                  <a:pt x="29" y="754"/>
                </a:lnTo>
                <a:lnTo>
                  <a:pt x="19" y="700"/>
                </a:lnTo>
                <a:lnTo>
                  <a:pt x="13" y="647"/>
                </a:lnTo>
                <a:lnTo>
                  <a:pt x="13" y="592"/>
                </a:lnTo>
                <a:lnTo>
                  <a:pt x="18" y="539"/>
                </a:lnTo>
                <a:lnTo>
                  <a:pt x="27" y="486"/>
                </a:lnTo>
                <a:lnTo>
                  <a:pt x="41" y="434"/>
                </a:lnTo>
                <a:lnTo>
                  <a:pt x="61" y="384"/>
                </a:lnTo>
                <a:lnTo>
                  <a:pt x="83" y="335"/>
                </a:lnTo>
                <a:lnTo>
                  <a:pt x="111" y="288"/>
                </a:lnTo>
                <a:lnTo>
                  <a:pt x="141" y="244"/>
                </a:lnTo>
                <a:lnTo>
                  <a:pt x="176" y="203"/>
                </a:lnTo>
                <a:lnTo>
                  <a:pt x="216" y="166"/>
                </a:lnTo>
                <a:lnTo>
                  <a:pt x="257" y="131"/>
                </a:lnTo>
                <a:lnTo>
                  <a:pt x="303" y="101"/>
                </a:lnTo>
                <a:lnTo>
                  <a:pt x="350" y="75"/>
                </a:lnTo>
                <a:lnTo>
                  <a:pt x="398" y="54"/>
                </a:lnTo>
                <a:lnTo>
                  <a:pt x="450" y="37"/>
                </a:lnTo>
                <a:lnTo>
                  <a:pt x="502" y="25"/>
                </a:lnTo>
                <a:lnTo>
                  <a:pt x="555" y="16"/>
                </a:lnTo>
                <a:lnTo>
                  <a:pt x="610" y="13"/>
                </a:lnTo>
                <a:lnTo>
                  <a:pt x="622" y="14"/>
                </a:lnTo>
                <a:lnTo>
                  <a:pt x="622" y="0"/>
                </a:lnTo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7"/>
          <p:cNvSpPr/>
          <p:nvPr/>
        </p:nvSpPr>
        <p:spPr>
          <a:xfrm>
            <a:off x="2230560" y="2131920"/>
            <a:ext cx="1944720" cy="1943280"/>
          </a:xfrm>
          <a:prstGeom prst="ellipse">
            <a:avLst/>
          </a:prstGeom>
          <a:noFill/>
          <a:ln w="34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9"/>
          <p:cNvSpPr/>
          <p:nvPr/>
        </p:nvSpPr>
        <p:spPr>
          <a:xfrm flipV="1">
            <a:off x="3218040" y="2131920"/>
            <a:ext cx="1440" cy="22320"/>
          </a:xfrm>
          <a:prstGeom prst="line">
            <a:avLst/>
          </a:prstGeom>
          <a:ln w="0">
            <a:solidFill>
              <a:srgbClr val="cccc99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0"/>
          <p:cNvSpPr/>
          <p:nvPr/>
        </p:nvSpPr>
        <p:spPr>
          <a:xfrm>
            <a:off x="2990520" y="2954160"/>
            <a:ext cx="303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mp13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1"/>
          <p:cNvSpPr/>
          <p:nvPr/>
        </p:nvSpPr>
        <p:spPr>
          <a:xfrm>
            <a:off x="3078360" y="3141720"/>
            <a:ext cx="342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3525 b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12"/>
          <p:cNvSpPr/>
          <p:nvPr/>
        </p:nvSpPr>
        <p:spPr>
          <a:xfrm>
            <a:off x="3122640" y="2198520"/>
            <a:ext cx="431640" cy="149400"/>
          </a:xfrm>
          <a:custGeom>
            <a:avLst/>
            <a:gdLst>
              <a:gd name="textAreaLeft" fmla="*/ 0 w 431640"/>
              <a:gd name="textAreaRight" fmla="*/ 432000 w 431640"/>
              <a:gd name="textAreaTop" fmla="*/ 0 h 149400"/>
              <a:gd name="textAreaBottom" fmla="*/ 149760 h 149400"/>
            </a:gdLst>
            <a:ahLst/>
            <a:rect l="textAreaLeft" t="textAreaTop" r="textAreaRight" b="textAreaBottom"/>
            <a:pathLst>
              <a:path w="297" h="94">
                <a:moveTo>
                  <a:pt x="297" y="49"/>
                </a:moveTo>
                <a:lnTo>
                  <a:pt x="243" y="29"/>
                </a:lnTo>
                <a:lnTo>
                  <a:pt x="188" y="14"/>
                </a:lnTo>
                <a:lnTo>
                  <a:pt x="134" y="5"/>
                </a:lnTo>
                <a:lnTo>
                  <a:pt x="76" y="0"/>
                </a:lnTo>
                <a:lnTo>
                  <a:pt x="20" y="0"/>
                </a:lnTo>
                <a:lnTo>
                  <a:pt x="0" y="2"/>
                </a:lnTo>
                <a:lnTo>
                  <a:pt x="4" y="52"/>
                </a:lnTo>
                <a:lnTo>
                  <a:pt x="56" y="50"/>
                </a:lnTo>
                <a:lnTo>
                  <a:pt x="109" y="52"/>
                </a:lnTo>
                <a:lnTo>
                  <a:pt x="161" y="59"/>
                </a:lnTo>
                <a:lnTo>
                  <a:pt x="211" y="72"/>
                </a:lnTo>
                <a:lnTo>
                  <a:pt x="262" y="88"/>
                </a:lnTo>
                <a:lnTo>
                  <a:pt x="278" y="94"/>
                </a:lnTo>
                <a:lnTo>
                  <a:pt x="297" y="49"/>
                </a:lnTo>
                <a:close/>
              </a:path>
            </a:pathLst>
          </a:custGeom>
          <a:solidFill>
            <a:srgbClr val="fffff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8"/>
          <p:cNvSpPr/>
          <p:nvPr/>
        </p:nvSpPr>
        <p:spPr>
          <a:xfrm rot="16200000">
            <a:off x="3164760" y="2354400"/>
            <a:ext cx="3049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6-E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19"/>
          <p:cNvSpPr/>
          <p:nvPr/>
        </p:nvSpPr>
        <p:spPr>
          <a:xfrm>
            <a:off x="3024360" y="2265480"/>
            <a:ext cx="120600" cy="93600"/>
          </a:xfrm>
          <a:custGeom>
            <a:avLst/>
            <a:gdLst>
              <a:gd name="textAreaLeft" fmla="*/ 0 w 120600"/>
              <a:gd name="textAreaRight" fmla="*/ 120960 w 120600"/>
              <a:gd name="textAreaTop" fmla="*/ 0 h 93600"/>
              <a:gd name="textAreaBottom" fmla="*/ 93960 h 93600"/>
            </a:gdLst>
            <a:ahLst/>
            <a:rect l="textAreaLeft" t="textAreaTop" r="textAreaRight" b="textAreaBottom"/>
            <a:pathLst>
              <a:path w="76" h="59">
                <a:moveTo>
                  <a:pt x="72" y="0"/>
                </a:moveTo>
                <a:lnTo>
                  <a:pt x="20" y="6"/>
                </a:lnTo>
                <a:lnTo>
                  <a:pt x="0" y="11"/>
                </a:lnTo>
                <a:lnTo>
                  <a:pt x="11" y="59"/>
                </a:lnTo>
                <a:lnTo>
                  <a:pt x="58" y="52"/>
                </a:lnTo>
                <a:lnTo>
                  <a:pt x="76" y="50"/>
                </a:lnTo>
                <a:lnTo>
                  <a:pt x="72" y="0"/>
                </a:lnTo>
                <a:close/>
              </a:path>
            </a:pathLst>
          </a:custGeom>
          <a:solidFill>
            <a:srgbClr val="fffff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rc 21"/>
          <p:cNvSpPr/>
          <p:nvPr/>
        </p:nvSpPr>
        <p:spPr>
          <a:xfrm>
            <a:off x="3041640" y="2344680"/>
            <a:ext cx="160200" cy="760320"/>
          </a:xfrm>
          <a:custGeom>
            <a:avLst/>
            <a:gdLst>
              <a:gd name="textAreaLeft" fmla="*/ 0 w 160200"/>
              <a:gd name="textAreaRight" fmla="*/ 160560 w 160200"/>
              <a:gd name="textAreaTop" fmla="*/ 0 h 760320"/>
              <a:gd name="textAreaBottom" fmla="*/ 760680 h 760320"/>
            </a:gdLst>
            <a:ahLst/>
            <a:rect l="textAreaLeft" t="textAreaTop" r="textAreaRight" b="textAreaBottom"/>
            <a:pathLst>
              <a:path fill="none" w="4538" h="21539">
                <a:moveTo>
                  <a:pt x="0" y="421"/>
                </a:moveTo>
                <a:cubicBezTo>
                  <a:pt x="962" y="214"/>
                  <a:pt x="1937" y="73"/>
                  <a:pt x="2918" y="-1"/>
                </a:cubicBezTo>
              </a:path>
              <a:path stroke="0" w="4538" h="21539">
                <a:moveTo>
                  <a:pt x="0" y="421"/>
                </a:moveTo>
                <a:cubicBezTo>
                  <a:pt x="962" y="214"/>
                  <a:pt x="1937" y="73"/>
                  <a:pt x="2918" y="-1"/>
                </a:cubicBezTo>
                <a:lnTo>
                  <a:pt x="4538" y="21539"/>
                </a:lnTo>
                <a:close/>
              </a:path>
            </a:pathLst>
          </a:custGeom>
          <a:noFill/>
          <a:ln w="0">
            <a:solidFill>
              <a:srgbClr val="993333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5"/>
          <p:cNvSpPr/>
          <p:nvPr/>
        </p:nvSpPr>
        <p:spPr>
          <a:xfrm rot="16200000">
            <a:off x="2964600" y="2484000"/>
            <a:ext cx="285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12-E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8"/>
          <p:cNvSpPr/>
          <p:nvPr/>
        </p:nvSpPr>
        <p:spPr>
          <a:xfrm>
            <a:off x="3191760" y="1700280"/>
            <a:ext cx="5126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s</a:t>
            </a: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ite (1-19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9"/>
          <p:cNvSpPr/>
          <p:nvPr/>
        </p:nvSpPr>
        <p:spPr>
          <a:xfrm flipH="1">
            <a:off x="3592080" y="2060640"/>
            <a:ext cx="58680" cy="139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32"/>
          <p:cNvSpPr/>
          <p:nvPr/>
        </p:nvSpPr>
        <p:spPr>
          <a:xfrm>
            <a:off x="3695040" y="1916280"/>
            <a:ext cx="339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(2055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36"/>
          <p:cNvSpPr/>
          <p:nvPr/>
        </p:nvSpPr>
        <p:spPr>
          <a:xfrm>
            <a:off x="3911040" y="2104920"/>
            <a:ext cx="339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2(3516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7"/>
          <p:cNvSpPr/>
          <p:nvPr/>
        </p:nvSpPr>
        <p:spPr>
          <a:xfrm flipH="1" flipV="1">
            <a:off x="4052880" y="3573360"/>
            <a:ext cx="133200" cy="74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0"/>
          <p:cNvSpPr/>
          <p:nvPr/>
        </p:nvSpPr>
        <p:spPr>
          <a:xfrm>
            <a:off x="4201200" y="3613320"/>
            <a:ext cx="406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(11060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4"/>
          <p:cNvSpPr/>
          <p:nvPr/>
        </p:nvSpPr>
        <p:spPr>
          <a:xfrm>
            <a:off x="3885480" y="3990960"/>
            <a:ext cx="406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4 (13311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8"/>
          <p:cNvSpPr/>
          <p:nvPr/>
        </p:nvSpPr>
        <p:spPr>
          <a:xfrm>
            <a:off x="2772720" y="4218120"/>
            <a:ext cx="406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5 (17935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2"/>
          <p:cNvSpPr/>
          <p:nvPr/>
        </p:nvSpPr>
        <p:spPr>
          <a:xfrm>
            <a:off x="2731320" y="1852560"/>
            <a:ext cx="406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6 (33079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56"/>
          <p:cNvSpPr/>
          <p:nvPr/>
        </p:nvSpPr>
        <p:spPr>
          <a:xfrm>
            <a:off x="3913920" y="2197080"/>
            <a:ext cx="366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1 (3554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60"/>
          <p:cNvSpPr/>
          <p:nvPr/>
        </p:nvSpPr>
        <p:spPr>
          <a:xfrm>
            <a:off x="4058280" y="2317680"/>
            <a:ext cx="366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2 (4511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61"/>
          <p:cNvSpPr/>
          <p:nvPr/>
        </p:nvSpPr>
        <p:spPr>
          <a:xfrm flipH="1" flipV="1">
            <a:off x="3970080" y="3709800"/>
            <a:ext cx="120600" cy="9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64"/>
          <p:cNvSpPr/>
          <p:nvPr/>
        </p:nvSpPr>
        <p:spPr>
          <a:xfrm>
            <a:off x="4096800" y="375300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3 (1178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65"/>
          <p:cNvSpPr/>
          <p:nvPr/>
        </p:nvSpPr>
        <p:spPr>
          <a:xfrm flipH="1" flipV="1">
            <a:off x="3860280" y="3817440"/>
            <a:ext cx="101880" cy="111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68"/>
          <p:cNvSpPr/>
          <p:nvPr/>
        </p:nvSpPr>
        <p:spPr>
          <a:xfrm>
            <a:off x="3971160" y="388764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4 (12811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69"/>
          <p:cNvSpPr/>
          <p:nvPr/>
        </p:nvSpPr>
        <p:spPr>
          <a:xfrm flipH="1" flipV="1">
            <a:off x="3699000" y="3940200"/>
            <a:ext cx="77760" cy="130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72"/>
          <p:cNvSpPr/>
          <p:nvPr/>
        </p:nvSpPr>
        <p:spPr>
          <a:xfrm>
            <a:off x="3764880" y="407988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5 (13915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73"/>
          <p:cNvSpPr/>
          <p:nvPr/>
        </p:nvSpPr>
        <p:spPr>
          <a:xfrm flipH="1" flipV="1">
            <a:off x="3639960" y="3970080"/>
            <a:ext cx="66960" cy="13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76"/>
          <p:cNvSpPr/>
          <p:nvPr/>
        </p:nvSpPr>
        <p:spPr>
          <a:xfrm>
            <a:off x="3320280" y="409716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6 (14215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80"/>
          <p:cNvSpPr/>
          <p:nvPr/>
        </p:nvSpPr>
        <p:spPr>
          <a:xfrm>
            <a:off x="2777400" y="430704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7 (17969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84"/>
          <p:cNvSpPr/>
          <p:nvPr/>
        </p:nvSpPr>
        <p:spPr>
          <a:xfrm>
            <a:off x="2326680" y="4076640"/>
            <a:ext cx="41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8 (18687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88"/>
          <p:cNvSpPr/>
          <p:nvPr/>
        </p:nvSpPr>
        <p:spPr>
          <a:xfrm>
            <a:off x="1981440" y="3848040"/>
            <a:ext cx="456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9   (21793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89"/>
          <p:cNvSpPr/>
          <p:nvPr/>
        </p:nvSpPr>
        <p:spPr>
          <a:xfrm flipV="1">
            <a:off x="2297160" y="3676320"/>
            <a:ext cx="122040" cy="9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92"/>
          <p:cNvSpPr/>
          <p:nvPr/>
        </p:nvSpPr>
        <p:spPr>
          <a:xfrm>
            <a:off x="1987200" y="3760920"/>
            <a:ext cx="45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10 (21817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93"/>
          <p:cNvSpPr/>
          <p:nvPr/>
        </p:nvSpPr>
        <p:spPr>
          <a:xfrm flipV="1">
            <a:off x="2241720" y="3613320"/>
            <a:ext cx="12852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96"/>
          <p:cNvSpPr/>
          <p:nvPr/>
        </p:nvSpPr>
        <p:spPr>
          <a:xfrm>
            <a:off x="1764720" y="3645000"/>
            <a:ext cx="45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11 (22201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00"/>
          <p:cNvSpPr/>
          <p:nvPr/>
        </p:nvSpPr>
        <p:spPr>
          <a:xfrm>
            <a:off x="2484000" y="1938240"/>
            <a:ext cx="45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12 (32366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1"/>
          <p:cNvSpPr/>
          <p:nvPr/>
        </p:nvSpPr>
        <p:spPr>
          <a:xfrm flipH="1" flipV="1">
            <a:off x="3779640" y="3884400"/>
            <a:ext cx="90360" cy="120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群組 54"/>
          <p:cNvGrpSpPr/>
          <p:nvPr/>
        </p:nvGrpSpPr>
        <p:grpSpPr>
          <a:xfrm>
            <a:off x="3206880" y="2057400"/>
            <a:ext cx="38880" cy="74880"/>
            <a:chOff x="3206880" y="2057400"/>
            <a:chExt cx="38880" cy="74880"/>
          </a:xfrm>
        </p:grpSpPr>
        <p:sp>
          <p:nvSpPr>
            <p:cNvPr id="87" name="直線接點 49"/>
            <p:cNvSpPr/>
            <p:nvPr/>
          </p:nvSpPr>
          <p:spPr>
            <a:xfrm flipH="1">
              <a:off x="3206880" y="2057400"/>
              <a:ext cx="9360" cy="66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線接點 51"/>
            <p:cNvSpPr/>
            <p:nvPr/>
          </p:nvSpPr>
          <p:spPr>
            <a:xfrm>
              <a:off x="3211200" y="2061720"/>
              <a:ext cx="34560" cy="5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線接點 53"/>
            <p:cNvSpPr/>
            <p:nvPr/>
          </p:nvSpPr>
          <p:spPr>
            <a:xfrm flipH="1">
              <a:off x="3234240" y="2066040"/>
              <a:ext cx="9360" cy="66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群組 91"/>
          <p:cNvGrpSpPr/>
          <p:nvPr/>
        </p:nvGrpSpPr>
        <p:grpSpPr>
          <a:xfrm>
            <a:off x="5025960" y="1921680"/>
            <a:ext cx="1177920" cy="2301120"/>
            <a:chOff x="5025960" y="1921680"/>
            <a:chExt cx="1177920" cy="2301120"/>
          </a:xfrm>
        </p:grpSpPr>
        <p:sp>
          <p:nvSpPr>
            <p:cNvPr id="91" name="文字方塊 214"/>
            <p:cNvSpPr/>
            <p:nvPr/>
          </p:nvSpPr>
          <p:spPr>
            <a:xfrm>
              <a:off x="5160600" y="222552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文字方塊 217"/>
            <p:cNvSpPr/>
            <p:nvPr/>
          </p:nvSpPr>
          <p:spPr>
            <a:xfrm rot="16200000">
              <a:off x="5259240" y="207540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TW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coR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文字方塊 218"/>
            <p:cNvSpPr/>
            <p:nvPr/>
          </p:nvSpPr>
          <p:spPr>
            <a:xfrm>
              <a:off x="5627160" y="220752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文字方塊 220"/>
            <p:cNvSpPr/>
            <p:nvPr/>
          </p:nvSpPr>
          <p:spPr>
            <a:xfrm rot="16200000">
              <a:off x="5665680" y="208476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TW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coR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5" name="Picture 94" descr=""/>
            <p:cNvPicPr/>
            <p:nvPr/>
          </p:nvPicPr>
          <p:blipFill>
            <a:blip r:embed="rId1">
              <a:lum contrast="12000"/>
            </a:blip>
            <a:srcRect l="9233" t="63031" r="82693" b="0"/>
            <a:stretch/>
          </p:blipFill>
          <p:spPr>
            <a:xfrm>
              <a:off x="5025960" y="2415960"/>
              <a:ext cx="416880" cy="1806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6" name="Picture 94" descr=""/>
            <p:cNvPicPr/>
            <p:nvPr/>
          </p:nvPicPr>
          <p:blipFill>
            <a:blip r:embed="rId2">
              <a:lum contrast="12000"/>
            </a:blip>
            <a:srcRect l="26107" t="63031" r="70003" b="0"/>
            <a:stretch/>
          </p:blipFill>
          <p:spPr>
            <a:xfrm>
              <a:off x="5443920" y="2415960"/>
              <a:ext cx="200880" cy="1806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94" descr=""/>
            <p:cNvPicPr/>
            <p:nvPr/>
          </p:nvPicPr>
          <p:blipFill>
            <a:blip r:embed="rId3">
              <a:lum contrast="12000"/>
            </a:blip>
            <a:srcRect l="30001" t="63031" r="65386" b="0"/>
            <a:stretch/>
          </p:blipFill>
          <p:spPr>
            <a:xfrm>
              <a:off x="5641560" y="2415960"/>
              <a:ext cx="238320" cy="1806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94" descr=""/>
            <p:cNvPicPr/>
            <p:nvPr/>
          </p:nvPicPr>
          <p:blipFill>
            <a:blip r:embed="rId4">
              <a:lum contrast="12000"/>
            </a:blip>
            <a:srcRect l="42646" t="63031" r="50384" b="0"/>
            <a:stretch/>
          </p:blipFill>
          <p:spPr>
            <a:xfrm>
              <a:off x="5843880" y="2415960"/>
              <a:ext cx="360000" cy="1806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9" name="文字方塊 92"/>
          <p:cNvSpPr/>
          <p:nvPr/>
        </p:nvSpPr>
        <p:spPr>
          <a:xfrm>
            <a:off x="1619280" y="1546200"/>
            <a:ext cx="43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文字方塊 93"/>
          <p:cNvSpPr/>
          <p:nvPr/>
        </p:nvSpPr>
        <p:spPr>
          <a:xfrm>
            <a:off x="4714920" y="1547640"/>
            <a:ext cx="433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143000" y="4876920"/>
            <a:ext cx="70102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200" spc="-1" strike="noStrike">
                <a:solidFill>
                  <a:srgbClr val="000000"/>
                </a:solidFill>
                <a:latin typeface="Times New Roman"/>
              </a:rPr>
              <a:t>Figure S1  Strategy employed to test whether Smp131 has a circular form of genome.</a:t>
            </a:r>
            <a:r>
              <a:rPr b="0" lang="zh-TW" sz="1200" spc="-1" strike="noStrike">
                <a:solidFill>
                  <a:srgbClr val="000000"/>
                </a:solidFill>
                <a:latin typeface="Times New Roman"/>
              </a:rPr>
              <a:t>  Lines: 1, restriction map deduced from the Smp131 sequence determined in this study; 2, fragments E1-3 (2.5 kb) and E5B1 (0.7 kb) used as probes for Southern hybridization; 3 and 4, 4.7-kb AvaI fragment (A1) and 4.7-kb EcoRV fragment (B5), respectively, that would hybridize to probes EI-3 and E5BI should the genome be circular. (B) Southern hybridization of AvaI and EcoRV digests from Smp131 genome using E1-3 and E5B1 separately as probe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user</cp:lastModifiedBy>
  <dcterms:modified xsi:type="dcterms:W3CDTF">2014-01-12T09:53:33Z</dcterms:modified>
  <cp:revision>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